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6/06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807586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Palmer et al (2019) Diabetologia DOI 10.1007/s00125-019-4934-x </a:t>
            </a:r>
          </a:p>
          <a:p>
            <a:r>
              <a:rPr lang="en-GB" sz="1200" dirty="0"/>
              <a:t>© The Authors 2019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6B9F3C9-8E72-4210-AB3A-3DF03FC56E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0213" y="188640"/>
            <a:ext cx="4423573" cy="57143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260648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onsequences of fundamental ageing processe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91862AE-C381-4A9C-AC2F-75C10330936D}"/>
              </a:ext>
            </a:extLst>
          </p:cNvPr>
          <p:cNvSpPr txBox="1"/>
          <p:nvPr/>
        </p:nvSpPr>
        <p:spPr>
          <a:xfrm>
            <a:off x="251520" y="5807586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Palmer et al (2019) Diabetologia DOI 10.1007/s00125-019-4934-x </a:t>
            </a:r>
          </a:p>
          <a:p>
            <a:r>
              <a:rPr lang="en-GB" sz="1200" dirty="0"/>
              <a:t>© </a:t>
            </a:r>
            <a:r>
              <a:rPr lang="en-GB" sz="1200"/>
              <a:t>The Authors 2019</a:t>
            </a:r>
            <a:endParaRPr lang="en-GB" sz="12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2B6B3CD-E13B-49A6-BE57-687FCC3F81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6119" y="824726"/>
            <a:ext cx="5791761" cy="51617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0368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</TotalTime>
  <Words>36</Words>
  <Application>Microsoft Office PowerPoint</Application>
  <PresentationFormat>On-screen Show (4:3)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1</cp:revision>
  <dcterms:created xsi:type="dcterms:W3CDTF">2016-06-15T12:53:43Z</dcterms:created>
  <dcterms:modified xsi:type="dcterms:W3CDTF">2019-06-26T14:32:37Z</dcterms:modified>
</cp:coreProperties>
</file>